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 bookmarkIdSeed="24">
  <p:sldMasterIdLst>
    <p:sldMasterId id="2147483840" r:id="rId1"/>
  </p:sldMasterIdLst>
  <p:notesMasterIdLst>
    <p:notesMasterId r:id="rId3"/>
  </p:notesMasterIdLst>
  <p:sldIdLst>
    <p:sldId id="298" r:id="rId2"/>
  </p:sldIdLst>
  <p:sldSz cx="73152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1CD8B72-5FF1-4F32-8C2C-D7B4478E4F1D}">
          <p14:sldIdLst>
            <p14:sldId id="29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7FB36E-97C1-D6CC-FC60-8D30DA5DA027}" name="Arik Davidyan" initials="AD" userId="S::davidyana@omrf.org::8ca9df27-1e11-474e-a10a-be4812d5a88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30" autoAdjust="0"/>
    <p:restoredTop sz="93645" autoAdjust="0"/>
  </p:normalViewPr>
  <p:slideViewPr>
    <p:cSldViewPr snapToGrid="0">
      <p:cViewPr varScale="1">
        <p:scale>
          <a:sx n="111" d="100"/>
          <a:sy n="111" d="100"/>
        </p:scale>
        <p:origin x="4396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A46E605-F6B1-403E-A899-FABDB04BC04A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3788" y="1162050"/>
            <a:ext cx="22828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4F2219B-4F43-4EA6-982C-2FB4872F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40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F2219B-4F43-4EA6-982C-2FB4872F379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7621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3326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3429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885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719311A-ACB0-1F7B-D2CB-EC637A3F6E17}"/>
              </a:ext>
            </a:extLst>
          </p:cNvPr>
          <p:cNvCxnSpPr/>
          <p:nvPr userDrawn="1"/>
        </p:nvCxnSpPr>
        <p:spPr>
          <a:xfrm>
            <a:off x="870948" y="1477978"/>
            <a:ext cx="576451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492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80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6735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863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649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709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8130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3108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4732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6D62670-123B-D5D1-F825-6804355B11DB}"/>
              </a:ext>
            </a:extLst>
          </p:cNvPr>
          <p:cNvSpPr txBox="1"/>
          <p:nvPr/>
        </p:nvSpPr>
        <p:spPr>
          <a:xfrm>
            <a:off x="1555753" y="6233568"/>
            <a:ext cx="56426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igure 1: a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ter consumption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tformin dosing by week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-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bsolute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-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relative muscle masse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ody water Enrichment. </a:t>
            </a:r>
            <a:r>
              <a:rPr lang="en-US" sz="1200" dirty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Data were analyzed by two-way repeated measures ANOVA (group x time) and are represented as mean ± SEM from 6-7 rats per group. *p &lt; 0.05 difference between HCR-MET-WO and LCR-MET. 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61BC787-827F-7C10-A215-267F242F72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9926524"/>
              </p:ext>
            </p:extLst>
          </p:nvPr>
        </p:nvGraphicFramePr>
        <p:xfrm>
          <a:off x="265112" y="328613"/>
          <a:ext cx="6784975" cy="2732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6784237" imgH="2732758" progId="Prism9.Document">
                  <p:embed/>
                </p:oleObj>
              </mc:Choice>
              <mc:Fallback>
                <p:oleObj name="Prism 9" r:id="rId3" imgW="6784237" imgH="273275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5112" y="328613"/>
                        <a:ext cx="6784975" cy="2732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B4D3B8D-DEE7-FF1B-5546-24D9424D79EC}"/>
              </a:ext>
            </a:extLst>
          </p:cNvPr>
          <p:cNvSpPr txBox="1"/>
          <p:nvPr/>
        </p:nvSpPr>
        <p:spPr>
          <a:xfrm>
            <a:off x="620250" y="513401"/>
            <a:ext cx="392968" cy="2586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81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FABBFA8-93BE-E21D-09CC-9ABD7AE8322D}"/>
              </a:ext>
            </a:extLst>
          </p:cNvPr>
          <p:cNvSpPr txBox="1"/>
          <p:nvPr/>
        </p:nvSpPr>
        <p:spPr>
          <a:xfrm>
            <a:off x="3497995" y="512452"/>
            <a:ext cx="392968" cy="2586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81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959CB30-12C6-A95C-6ABA-6143EDA7BC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7673133"/>
              </p:ext>
            </p:extLst>
          </p:nvPr>
        </p:nvGraphicFramePr>
        <p:xfrm>
          <a:off x="5975350" y="2534517"/>
          <a:ext cx="1074737" cy="5261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1907279" imgH="932882" progId="Prism9.Document">
                  <p:embed/>
                </p:oleObj>
              </mc:Choice>
              <mc:Fallback>
                <p:oleObj name="Prism 9" r:id="rId5" imgW="1907279" imgH="932882" progId="Prism9.Document">
                  <p:embed/>
                  <p:pic>
                    <p:nvPicPr>
                      <p:cNvPr id="55" name="Object 54">
                        <a:extLst>
                          <a:ext uri="{FF2B5EF4-FFF2-40B4-BE49-F238E27FC236}">
                            <a16:creationId xmlns:a16="http://schemas.microsoft.com/office/drawing/2014/main" id="{27BA69DA-6C9B-1428-60F8-9C2552FF6A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75350" y="2534517"/>
                        <a:ext cx="1074737" cy="5261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EA55EE4-077E-BD5D-CBC2-8D87C38B26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4170770"/>
              </p:ext>
            </p:extLst>
          </p:nvPr>
        </p:nvGraphicFramePr>
        <p:xfrm>
          <a:off x="138840" y="2858119"/>
          <a:ext cx="7111277" cy="3224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8174721" imgH="3706685" progId="Prism10.Document">
                  <p:embed/>
                </p:oleObj>
              </mc:Choice>
              <mc:Fallback>
                <p:oleObj name="Prism 10" r:id="rId7" imgW="8174721" imgH="370668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8840" y="2858119"/>
                        <a:ext cx="7111277" cy="3224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3F7D862-F695-99BF-6156-23D3F863C3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1074360"/>
              </p:ext>
            </p:extLst>
          </p:nvPr>
        </p:nvGraphicFramePr>
        <p:xfrm>
          <a:off x="265112" y="5941714"/>
          <a:ext cx="1339833" cy="15993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876764" imgH="3434130" progId="Prism10.Document">
                  <p:embed/>
                </p:oleObj>
              </mc:Choice>
              <mc:Fallback>
                <p:oleObj name="Prism 10" r:id="rId9" imgW="2876764" imgH="343413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65112" y="5941714"/>
                        <a:ext cx="1339833" cy="15993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68741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402</TotalTime>
  <Words>72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rism 10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formin treatment effects on protein turnover in the HCR/LCR rat model</dc:title>
  <dc:creator>Matt Bubak</dc:creator>
  <cp:lastModifiedBy>Matthew Bubak</cp:lastModifiedBy>
  <cp:revision>318</cp:revision>
  <cp:lastPrinted>2023-12-15T16:29:23Z</cp:lastPrinted>
  <dcterms:created xsi:type="dcterms:W3CDTF">2022-07-14T20:18:29Z</dcterms:created>
  <dcterms:modified xsi:type="dcterms:W3CDTF">2024-03-01T16:37:32Z</dcterms:modified>
</cp:coreProperties>
</file>